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A124C-8BA8-545A-F057-C1520E5DFE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650F6F-92E4-E35C-1CAE-61E0718E8F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8F5B38-F756-E81A-3A2C-AF429EF2F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803768-39BF-3CC9-3C6F-4D8332FDB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DF7E43-5FCC-022E-25AF-920F1C2A7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626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047A2-1C25-5E00-10EE-4C71829C6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ACEFF3-5B93-13A9-7245-AAA8886000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56C214-171E-9D86-D343-4AA6967BC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21C20-5504-77C8-7EA0-1BF532D83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D5740-C83B-85EB-5AC2-4557B5029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90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7EDECF-5FA9-4C56-EBA7-E56EA0CBBC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312972-373F-8CF2-A5D4-8455E19872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4B96B-BA56-4F47-D6B3-3DACDCED3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92333C-8ADC-22E7-39A6-421374310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B2A983-E889-7A3C-3315-86846F28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30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9DF6ED-B096-BAE4-243E-DB14370D59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89C97C-8934-A5E7-578B-0FFF8170C0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0117BD-CFC5-5E2B-9C84-0F14A71A9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D49162-20DB-9993-705D-A4AEE9733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57876-9C15-48B8-E96E-B6C632D12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585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79108-7B88-C864-F801-541A19421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3E8AC4-C261-F647-ED41-14D14D8317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E50C35-8137-9B35-2286-7DEB1AFD6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77E6D-BB03-D39D-4AF7-248ECCA0D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E4CD0-8C0A-168D-279F-A214A5196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188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52B5C-9FB0-2FDD-D5A2-5EF2AE8A40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96CE5C-7956-0C55-6026-49F2D634A1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54D83A-3994-0EC1-BC3D-045E459075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1B86C-7517-C747-0F9A-338EFCC8C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6D2B0-8520-47F5-BFC0-ECD16111C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2D2F71-B7CA-7B7E-8626-4462EECF8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564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92A10-BCB5-A08D-897E-EBC96D971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90A0C1-375F-B47D-A351-2193697C5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9E43FE-E756-BAA9-6B7F-E5FABD8910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3397E6-A975-C0A3-9488-77CC857515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9BE692-A42F-0DDD-FD8E-751EA3CA13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5ED61E-E8FD-A7F0-8A27-E7F6096CB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9F4FE6-064B-DC9E-6DD5-B2F37E203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3F659E-29CF-027F-D83B-6D9291144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352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5D7FDD-381A-0C8A-1CD8-BF2874037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586BFB-38D1-DD58-8AFD-561F7BDB0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F97AE4-EC9F-5367-D570-D745723C4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664AB9-0A83-1191-9469-D3B06B91D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495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9901DE-562E-8304-B11E-6502FE5D7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7A78B2-16AA-4E8E-A24E-65A3867A0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9F9192-1906-6370-6BAB-1088F08AD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202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57859-1BBC-37E7-CD8A-B63E13478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F5A12C-0810-89AD-71C7-8F6339BEE3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9EBD71-0753-4DCB-D49A-8E65643685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2AD97B-CF25-F2FC-0E82-595068D44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921DC5-C2A3-666E-6971-898253711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ADCCF3-29C6-F98E-531E-92DAEB44A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158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F71CE-851E-5673-D9D2-8229A0E07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717588-84BD-2D56-116A-FE3253EC13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5470A3-F435-7AC6-67CA-698A35B0E9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300F9-217A-4E95-13EF-05CEE9BC8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1881F3-B37A-FFDF-DC5C-8BB76EB98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2BF0C8-7405-6592-CA34-F30D219FF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189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D4C821-1968-9BD3-5C2E-4A8970650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3A7D02-4424-90F6-4758-AF434C321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6BC530-38F8-BB58-60C5-68B23D7C4D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F1484-7CBE-053A-3F30-4853F78B34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E8A6D-CE11-B4D2-85BC-97E8DF3679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336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FFEEDD8-556F-A2D9-2A7C-68F5D83CD193}"/>
              </a:ext>
            </a:extLst>
          </p:cNvPr>
          <p:cNvSpPr txBox="1"/>
          <p:nvPr/>
        </p:nvSpPr>
        <p:spPr>
          <a:xfrm>
            <a:off x="3578301" y="1994363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K 29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BCD6996-C7BE-D02D-F57C-22F14CFB96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0546" y="1409934"/>
            <a:ext cx="1208922" cy="83138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DA34CCE-229D-5AC6-4023-8D339F57F92A}"/>
              </a:ext>
            </a:extLst>
          </p:cNvPr>
          <p:cNvSpPr txBox="1"/>
          <p:nvPr/>
        </p:nvSpPr>
        <p:spPr>
          <a:xfrm>
            <a:off x="5669007" y="1727194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E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52385B8-2451-63DA-5BBD-0647040BA1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42014" y="1497335"/>
            <a:ext cx="1429665" cy="892658"/>
          </a:xfrm>
          <a:prstGeom prst="rect">
            <a:avLst/>
          </a:prstGeom>
        </p:spPr>
      </p:pic>
      <p:pic>
        <p:nvPicPr>
          <p:cNvPr id="7" name="Picture 15" descr="2-Arachidonoylglycerol - Wikipedia">
            <a:extLst>
              <a:ext uri="{FF2B5EF4-FFF2-40B4-BE49-F238E27FC236}">
                <a16:creationId xmlns:a16="http://schemas.microsoft.com/office/drawing/2014/main" id="{D94B4B84-5218-F1F2-62D9-B0D7856CE3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8681" y="1334679"/>
            <a:ext cx="1337726" cy="1005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0EA8246-D02C-B042-786B-9E2F6A929C5D}"/>
              </a:ext>
            </a:extLst>
          </p:cNvPr>
          <p:cNvSpPr txBox="1"/>
          <p:nvPr/>
        </p:nvSpPr>
        <p:spPr>
          <a:xfrm>
            <a:off x="3422884" y="1785602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-A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EB10E0-66BC-ACCE-FB05-D7D46740A9FF}"/>
              </a:ext>
            </a:extLst>
          </p:cNvPr>
          <p:cNvSpPr txBox="1"/>
          <p:nvPr/>
        </p:nvSpPr>
        <p:spPr>
          <a:xfrm>
            <a:off x="7631854" y="1782173"/>
            <a:ext cx="8226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P55940</a:t>
            </a:r>
          </a:p>
        </p:txBody>
      </p:sp>
      <p:pic>
        <p:nvPicPr>
          <p:cNvPr id="10" name="Picture 9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63484564-B0A3-1E09-D591-8107056B73C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46" t="35935" r="45305" b="27263"/>
          <a:stretch/>
        </p:blipFill>
        <p:spPr>
          <a:xfrm>
            <a:off x="2934137" y="4571734"/>
            <a:ext cx="1519864" cy="932255"/>
          </a:xfrm>
          <a:prstGeom prst="rect">
            <a:avLst/>
          </a:prstGeom>
        </p:spPr>
      </p:pic>
      <p:pic>
        <p:nvPicPr>
          <p:cNvPr id="11" name="Picture 10" descr="Diagram&#10;&#10;Description automatically generated with low confidence">
            <a:extLst>
              <a:ext uri="{FF2B5EF4-FFF2-40B4-BE49-F238E27FC236}">
                <a16:creationId xmlns:a16="http://schemas.microsoft.com/office/drawing/2014/main" id="{2B234FDB-6F38-FF09-5C55-56A5390AC22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00" t="26829" r="43433" b="36154"/>
          <a:stretch/>
        </p:blipFill>
        <p:spPr>
          <a:xfrm>
            <a:off x="4875360" y="4551805"/>
            <a:ext cx="1516555" cy="92691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95DC958-2CF8-1C70-80B4-65A16963E56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154" t="4577" r="5154" b="10275"/>
          <a:stretch/>
        </p:blipFill>
        <p:spPr>
          <a:xfrm>
            <a:off x="6989768" y="4624831"/>
            <a:ext cx="1599019" cy="85388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A375937-8940-61E1-1E32-4D67538CD953}"/>
              </a:ext>
            </a:extLst>
          </p:cNvPr>
          <p:cNvSpPr txBox="1"/>
          <p:nvPr/>
        </p:nvSpPr>
        <p:spPr>
          <a:xfrm>
            <a:off x="3736034" y="4476459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H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956AB8D-6ED7-7F20-6D96-B5CF16E712D8}"/>
              </a:ext>
            </a:extLst>
          </p:cNvPr>
          <p:cNvSpPr txBox="1"/>
          <p:nvPr/>
        </p:nvSpPr>
        <p:spPr>
          <a:xfrm>
            <a:off x="8114036" y="4476459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B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42CD74C-CA40-A728-9A08-E8C1F0BBE27E}"/>
              </a:ext>
            </a:extLst>
          </p:cNvPr>
          <p:cNvSpPr txBox="1"/>
          <p:nvPr/>
        </p:nvSpPr>
        <p:spPr>
          <a:xfrm>
            <a:off x="5730004" y="4476459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HC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901A8398-573A-6520-EFFB-39DC512870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53216" y="2456783"/>
            <a:ext cx="1411791" cy="108628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41CA4A2-6477-C618-275B-40B99CA74A2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99749" y="2754018"/>
            <a:ext cx="959796" cy="44625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1E240A7-8DAA-B92E-9A41-F0C5D200C808}"/>
              </a:ext>
            </a:extLst>
          </p:cNvPr>
          <p:cNvSpPr txBox="1"/>
          <p:nvPr/>
        </p:nvSpPr>
        <p:spPr>
          <a:xfrm>
            <a:off x="4050276" y="245678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7EE2F13-608F-8CE9-5638-43B8FE1AA8F2}"/>
              </a:ext>
            </a:extLst>
          </p:cNvPr>
          <p:cNvSpPr txBox="1"/>
          <p:nvPr/>
        </p:nvSpPr>
        <p:spPr>
          <a:xfrm>
            <a:off x="6157999" y="2479094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lycerol</a:t>
            </a:r>
          </a:p>
        </p:txBody>
      </p:sp>
      <p:pic>
        <p:nvPicPr>
          <p:cNvPr id="26" name="Picture 25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4767D07C-E34A-1577-2E4E-5B0E8C2AAC8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22" t="38349" r="46128" b="31519"/>
          <a:stretch/>
        </p:blipFill>
        <p:spPr>
          <a:xfrm>
            <a:off x="7064749" y="3520775"/>
            <a:ext cx="1825269" cy="656150"/>
          </a:xfrm>
          <a:prstGeom prst="rect">
            <a:avLst/>
          </a:prstGeom>
        </p:spPr>
      </p:pic>
      <p:pic>
        <p:nvPicPr>
          <p:cNvPr id="27" name="Picture 26" descr="A picture containing text&#10;&#10;Description automatically generated">
            <a:extLst>
              <a:ext uri="{FF2B5EF4-FFF2-40B4-BE49-F238E27FC236}">
                <a16:creationId xmlns:a16="http://schemas.microsoft.com/office/drawing/2014/main" id="{DC762143-03F1-79E1-FF73-3B5EC870B771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54" t="40325" r="43567" b="34939"/>
          <a:stretch/>
        </p:blipFill>
        <p:spPr>
          <a:xfrm>
            <a:off x="2910419" y="3564300"/>
            <a:ext cx="1887314" cy="55426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69810AB-7063-849F-7693-F4F2AFB13F7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286" t="34783" r="4421" b="14629"/>
          <a:stretch/>
        </p:blipFill>
        <p:spPr>
          <a:xfrm>
            <a:off x="5025702" y="3565742"/>
            <a:ext cx="1812434" cy="55281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F9EF7B55-2009-65C7-4341-509FA171A196}"/>
              </a:ext>
            </a:extLst>
          </p:cNvPr>
          <p:cNvSpPr txBox="1"/>
          <p:nvPr/>
        </p:nvSpPr>
        <p:spPr>
          <a:xfrm>
            <a:off x="7512795" y="3455706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-O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A2A322D-27FF-B7F8-52B8-9301CBE9DAB6}"/>
              </a:ext>
            </a:extLst>
          </p:cNvPr>
          <p:cNvSpPr txBox="1"/>
          <p:nvPr/>
        </p:nvSpPr>
        <p:spPr>
          <a:xfrm>
            <a:off x="5454527" y="3455706"/>
            <a:ext cx="470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-L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CEAC11D-6F66-30A2-75E2-3B2C2451D891}"/>
              </a:ext>
            </a:extLst>
          </p:cNvPr>
          <p:cNvSpPr txBox="1"/>
          <p:nvPr/>
        </p:nvSpPr>
        <p:spPr>
          <a:xfrm>
            <a:off x="3370422" y="3455706"/>
            <a:ext cx="4985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-A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C3B6D6E-D870-C33B-DF87-396502564FB3}"/>
              </a:ext>
            </a:extLst>
          </p:cNvPr>
          <p:cNvSpPr txBox="1"/>
          <p:nvPr/>
        </p:nvSpPr>
        <p:spPr>
          <a:xfrm>
            <a:off x="62285" y="73349"/>
            <a:ext cx="662844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 Chemical structures of CB</a:t>
            </a:r>
            <a:r>
              <a:rPr lang="en-US" sz="1200" u="sng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R agents tested at GRAB</a:t>
            </a:r>
            <a:r>
              <a:rPr lang="en-US" sz="1200" u="sng" baseline="-25000" dirty="0">
                <a:latin typeface="Arial" panose="020B0604020202020204" pitchFamily="34" charset="0"/>
                <a:cs typeface="Arial" panose="020B0604020202020204" pitchFamily="34" charset="0"/>
              </a:rPr>
              <a:t>eCB2.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F44C4C9-EE48-C5B5-3F30-DC5A353A926F}"/>
              </a:ext>
            </a:extLst>
          </p:cNvPr>
          <p:cNvSpPr txBox="1"/>
          <p:nvPr/>
        </p:nvSpPr>
        <p:spPr>
          <a:xfrm>
            <a:off x="2775651" y="13280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09095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lla_lab8</dc:creator>
  <cp:lastModifiedBy>stella_lab8</cp:lastModifiedBy>
  <cp:revision>3</cp:revision>
  <dcterms:created xsi:type="dcterms:W3CDTF">2023-03-02T03:05:37Z</dcterms:created>
  <dcterms:modified xsi:type="dcterms:W3CDTF">2023-03-02T03:07:46Z</dcterms:modified>
</cp:coreProperties>
</file>